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885" autoAdjust="0"/>
  </p:normalViewPr>
  <p:slideViewPr>
    <p:cSldViewPr snapToObjects="1" showGuides="1">
      <p:cViewPr varScale="1">
        <p:scale>
          <a:sx n="91" d="100"/>
          <a:sy n="91" d="100"/>
        </p:scale>
        <p:origin x="-612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plate%20reader%20output1%20H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plate%20reader%20output1%20H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plate%20reader%20output1%20H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pper\homestd\My%20Documents\experiments\mutant%20screen%20year%203\ler0%20background%20mutants%20inc%20dmr\dmr%20mutants\homoserine%20inhibition\plate%20reader%20output1%20H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 b="0"/>
            </a:pPr>
            <a:r>
              <a:rPr lang="en-US" sz="1100" b="0" i="1" dirty="0" smtClean="0"/>
              <a:t>Fusarium</a:t>
            </a:r>
            <a:r>
              <a:rPr lang="en-US" sz="1100" b="0" i="1" baseline="0" dirty="0" smtClean="0"/>
              <a:t> culmorum</a:t>
            </a:r>
            <a:endParaRPr lang="en-US" sz="1100" b="0" dirty="0"/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Fc D-HS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50:$M$50</c:f>
                <c:numCache>
                  <c:formatCode>General</c:formatCode>
                  <c:ptCount val="12"/>
                  <c:pt idx="0">
                    <c:v>2.60117828535881E-2</c:v>
                  </c:pt>
                  <c:pt idx="1">
                    <c:v>1.08736014426378E-2</c:v>
                  </c:pt>
                  <c:pt idx="2">
                    <c:v>3.6654255712066403E-2</c:v>
                  </c:pt>
                  <c:pt idx="3">
                    <c:v>3.8764479075088301E-2</c:v>
                  </c:pt>
                  <c:pt idx="4">
                    <c:v>5.3331583738663403E-2</c:v>
                  </c:pt>
                  <c:pt idx="5">
                    <c:v>1.8139046759990202E-2</c:v>
                  </c:pt>
                  <c:pt idx="6">
                    <c:v>2.2504668754299399E-2</c:v>
                  </c:pt>
                  <c:pt idx="7">
                    <c:v>2.78755812927266E-2</c:v>
                  </c:pt>
                  <c:pt idx="8">
                    <c:v>1.1961648785458801E-2</c:v>
                  </c:pt>
                  <c:pt idx="9">
                    <c:v>1.0424119556035401E-2</c:v>
                  </c:pt>
                  <c:pt idx="10">
                    <c:v>5.53283287144415E-3</c:v>
                  </c:pt>
                  <c:pt idx="11">
                    <c:v>5.8564719660294902E-3</c:v>
                  </c:pt>
                </c:numCache>
              </c:numRef>
            </c:plus>
            <c:minus>
              <c:numRef>
                <c:f>Sheet1!$B$50:$M$50</c:f>
                <c:numCache>
                  <c:formatCode>General</c:formatCode>
                  <c:ptCount val="12"/>
                  <c:pt idx="0">
                    <c:v>2.60117828535881E-2</c:v>
                  </c:pt>
                  <c:pt idx="1">
                    <c:v>1.08736014426378E-2</c:v>
                  </c:pt>
                  <c:pt idx="2">
                    <c:v>3.6654255712066403E-2</c:v>
                  </c:pt>
                  <c:pt idx="3">
                    <c:v>3.8764479075088301E-2</c:v>
                  </c:pt>
                  <c:pt idx="4">
                    <c:v>5.3331583738663403E-2</c:v>
                  </c:pt>
                  <c:pt idx="5">
                    <c:v>1.8139046759990202E-2</c:v>
                  </c:pt>
                  <c:pt idx="6">
                    <c:v>2.2504668754299399E-2</c:v>
                  </c:pt>
                  <c:pt idx="7">
                    <c:v>2.78755812927266E-2</c:v>
                  </c:pt>
                  <c:pt idx="8">
                    <c:v>1.1961648785458801E-2</c:v>
                  </c:pt>
                  <c:pt idx="9">
                    <c:v>1.0424119556035401E-2</c:v>
                  </c:pt>
                  <c:pt idx="10">
                    <c:v>5.53283287144415E-3</c:v>
                  </c:pt>
                  <c:pt idx="11">
                    <c:v>5.8564719660294902E-3</c:v>
                  </c:pt>
                </c:numCache>
              </c:numRef>
            </c:minus>
          </c:errBars>
          <c:cat>
            <c:numRef>
              <c:f>Sheet1!$B$40:$M$40</c:f>
              <c:numCache>
                <c:formatCode>General</c:formatCode>
                <c:ptCount val="12"/>
                <c:pt idx="0">
                  <c:v>0</c:v>
                </c:pt>
                <c:pt idx="1">
                  <c:v>7.8125E-2</c:v>
                </c:pt>
                <c:pt idx="2">
                  <c:v>0.15625</c:v>
                </c:pt>
                <c:pt idx="3">
                  <c:v>0.3125</c:v>
                </c:pt>
                <c:pt idx="4">
                  <c:v>0.625</c:v>
                </c:pt>
                <c:pt idx="5">
                  <c:v>1.25</c:v>
                </c:pt>
                <c:pt idx="6">
                  <c:v>2.5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40</c:v>
                </c:pt>
                <c:pt idx="11">
                  <c:v>80</c:v>
                </c:pt>
              </c:numCache>
            </c:numRef>
          </c:cat>
          <c:val>
            <c:numRef>
              <c:f>Sheet1!$B$49:$M$49</c:f>
              <c:numCache>
                <c:formatCode>0.000</c:formatCode>
                <c:ptCount val="12"/>
                <c:pt idx="0">
                  <c:v>0.48386249999999997</c:v>
                </c:pt>
                <c:pt idx="1">
                  <c:v>0.51077916666666701</c:v>
                </c:pt>
                <c:pt idx="2">
                  <c:v>0.50661458333333298</c:v>
                </c:pt>
                <c:pt idx="3">
                  <c:v>0.48890416666666697</c:v>
                </c:pt>
                <c:pt idx="4">
                  <c:v>0.46049166666666702</c:v>
                </c:pt>
                <c:pt idx="5">
                  <c:v>0.47611041666666698</c:v>
                </c:pt>
                <c:pt idx="6">
                  <c:v>0.45563749999999997</c:v>
                </c:pt>
                <c:pt idx="7">
                  <c:v>0.46931250000000002</c:v>
                </c:pt>
                <c:pt idx="8">
                  <c:v>0.45048749999999999</c:v>
                </c:pt>
                <c:pt idx="9">
                  <c:v>0.46344166666666697</c:v>
                </c:pt>
                <c:pt idx="10">
                  <c:v>0.451252083333333</c:v>
                </c:pt>
                <c:pt idx="11">
                  <c:v>0.4407125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8078976"/>
        <c:axId val="89174784"/>
      </c:lineChart>
      <c:catAx>
        <c:axId val="880789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smtClean="0"/>
                  <a:t>D-homoserine </a:t>
                </a:r>
                <a:r>
                  <a:rPr lang="en-US" b="0" dirty="0" smtClean="0"/>
                  <a:t>concentration </a:t>
                </a:r>
                <a:r>
                  <a:rPr lang="en-US" b="0" dirty="0"/>
                  <a:t>(</a:t>
                </a:r>
                <a:r>
                  <a:rPr lang="en-US" b="0" dirty="0" err="1"/>
                  <a:t>mM</a:t>
                </a:r>
                <a:r>
                  <a:rPr lang="en-US" b="0" dirty="0"/>
                  <a:t>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9174784"/>
        <c:crosses val="autoZero"/>
        <c:auto val="1"/>
        <c:lblAlgn val="ctr"/>
        <c:lblOffset val="100"/>
        <c:noMultiLvlLbl val="0"/>
      </c:catAx>
      <c:valAx>
        <c:axId val="89174784"/>
        <c:scaling>
          <c:orientation val="minMax"/>
          <c:max val="0.65"/>
          <c:min val="0.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OD</a:t>
                </a:r>
                <a:r>
                  <a:rPr lang="en-US" baseline="-25000" dirty="0" smtClean="0"/>
                  <a:t>600</a:t>
                </a:r>
                <a:endParaRPr lang="en-US" dirty="0"/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crossAx val="88078976"/>
        <c:crosses val="autoZero"/>
        <c:crossBetween val="between"/>
        <c:majorUnit val="0.1"/>
        <c:minorUnit val="0.05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title>
      <c:tx>
        <c:rich>
          <a:bodyPr/>
          <a:lstStyle/>
          <a:p>
            <a:pPr>
              <a:defRPr sz="1100" b="0"/>
            </a:pPr>
            <a:r>
              <a:rPr lang="en-US" sz="1100" b="0" i="1" dirty="0" smtClean="0"/>
              <a:t>Fusarium</a:t>
            </a:r>
            <a:r>
              <a:rPr lang="en-US" sz="1100" b="0" i="1" baseline="0" dirty="0" smtClean="0"/>
              <a:t> graminearum</a:t>
            </a:r>
            <a:endParaRPr lang="en-US" sz="1100" b="0" dirty="0"/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1"/>
          <c:order val="0"/>
          <c:tx>
            <c:v>Fc D-HS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52:$L$52</c:f>
                <c:numCache>
                  <c:formatCode>General</c:formatCode>
                  <c:ptCount val="11"/>
                  <c:pt idx="0">
                    <c:v>1.6713083974118199E-2</c:v>
                  </c:pt>
                  <c:pt idx="1">
                    <c:v>3.6191203913944498E-3</c:v>
                  </c:pt>
                  <c:pt idx="2">
                    <c:v>5.4630704634746402E-3</c:v>
                  </c:pt>
                  <c:pt idx="3">
                    <c:v>4.8984756463013399E-3</c:v>
                  </c:pt>
                  <c:pt idx="4">
                    <c:v>7.9048987829395297E-3</c:v>
                  </c:pt>
                  <c:pt idx="5">
                    <c:v>2.0580521625322601E-3</c:v>
                  </c:pt>
                  <c:pt idx="6">
                    <c:v>1.30738949943801E-2</c:v>
                  </c:pt>
                  <c:pt idx="7">
                    <c:v>1.3628485580319E-2</c:v>
                  </c:pt>
                  <c:pt idx="8">
                    <c:v>5.8191852236087801E-3</c:v>
                  </c:pt>
                  <c:pt idx="9">
                    <c:v>5.1737289322900297E-3</c:v>
                  </c:pt>
                  <c:pt idx="10">
                    <c:v>1.21248978613491E-2</c:v>
                  </c:pt>
                </c:numCache>
              </c:numRef>
            </c:plus>
            <c:minus>
              <c:numRef>
                <c:f>Sheet1!$B$52:$L$52</c:f>
                <c:numCache>
                  <c:formatCode>General</c:formatCode>
                  <c:ptCount val="11"/>
                  <c:pt idx="0">
                    <c:v>1.6713083974118199E-2</c:v>
                  </c:pt>
                  <c:pt idx="1">
                    <c:v>3.6191203913944498E-3</c:v>
                  </c:pt>
                  <c:pt idx="2">
                    <c:v>5.4630704634746402E-3</c:v>
                  </c:pt>
                  <c:pt idx="3">
                    <c:v>4.8984756463013399E-3</c:v>
                  </c:pt>
                  <c:pt idx="4">
                    <c:v>7.9048987829395297E-3</c:v>
                  </c:pt>
                  <c:pt idx="5">
                    <c:v>2.0580521625322601E-3</c:v>
                  </c:pt>
                  <c:pt idx="6">
                    <c:v>1.30738949943801E-2</c:v>
                  </c:pt>
                  <c:pt idx="7">
                    <c:v>1.3628485580319E-2</c:v>
                  </c:pt>
                  <c:pt idx="8">
                    <c:v>5.8191852236087801E-3</c:v>
                  </c:pt>
                  <c:pt idx="9">
                    <c:v>5.1737289322900297E-3</c:v>
                  </c:pt>
                  <c:pt idx="10">
                    <c:v>1.21248978613491E-2</c:v>
                  </c:pt>
                </c:numCache>
              </c:numRef>
            </c:minus>
          </c:errBars>
          <c:cat>
            <c:numRef>
              <c:f>Sheet1!$B$40:$M$40</c:f>
              <c:numCache>
                <c:formatCode>General</c:formatCode>
                <c:ptCount val="12"/>
                <c:pt idx="0">
                  <c:v>0</c:v>
                </c:pt>
                <c:pt idx="1">
                  <c:v>7.8125E-2</c:v>
                </c:pt>
                <c:pt idx="2">
                  <c:v>0.15625</c:v>
                </c:pt>
                <c:pt idx="3">
                  <c:v>0.3125</c:v>
                </c:pt>
                <c:pt idx="4">
                  <c:v>0.625</c:v>
                </c:pt>
                <c:pt idx="5">
                  <c:v>1.25</c:v>
                </c:pt>
                <c:pt idx="6">
                  <c:v>2.5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40</c:v>
                </c:pt>
                <c:pt idx="11">
                  <c:v>80</c:v>
                </c:pt>
              </c:numCache>
            </c:numRef>
          </c:cat>
          <c:val>
            <c:numRef>
              <c:f>Sheet1!$B$51:$M$51</c:f>
              <c:numCache>
                <c:formatCode>0.000</c:formatCode>
                <c:ptCount val="12"/>
                <c:pt idx="0">
                  <c:v>0.46137499999999998</c:v>
                </c:pt>
                <c:pt idx="1">
                  <c:v>0.47030416666666702</c:v>
                </c:pt>
                <c:pt idx="2">
                  <c:v>0.46915000000000001</c:v>
                </c:pt>
                <c:pt idx="3">
                  <c:v>0.48708958333333302</c:v>
                </c:pt>
                <c:pt idx="4">
                  <c:v>0.49616874999999999</c:v>
                </c:pt>
                <c:pt idx="5">
                  <c:v>0.50511249999999996</c:v>
                </c:pt>
                <c:pt idx="6">
                  <c:v>0.49520625000000001</c:v>
                </c:pt>
                <c:pt idx="7">
                  <c:v>0.48972708333333298</c:v>
                </c:pt>
                <c:pt idx="8">
                  <c:v>0.49220833333333303</c:v>
                </c:pt>
                <c:pt idx="9">
                  <c:v>0.48993958333333298</c:v>
                </c:pt>
                <c:pt idx="10">
                  <c:v>0.50332500000000002</c:v>
                </c:pt>
                <c:pt idx="11">
                  <c:v>0.470895833333333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072192"/>
        <c:axId val="90074112"/>
      </c:lineChart>
      <c:catAx>
        <c:axId val="90072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smtClean="0"/>
                  <a:t>D-homoserine </a:t>
                </a:r>
                <a:r>
                  <a:rPr lang="en-US" b="0" dirty="0" smtClean="0"/>
                  <a:t>concentration </a:t>
                </a:r>
                <a:r>
                  <a:rPr lang="en-US" b="0" dirty="0"/>
                  <a:t>(</a:t>
                </a:r>
                <a:r>
                  <a:rPr lang="en-US" b="0" dirty="0" err="1"/>
                  <a:t>mM</a:t>
                </a:r>
                <a:r>
                  <a:rPr lang="en-US" b="0" dirty="0"/>
                  <a:t>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0074112"/>
        <c:crosses val="autoZero"/>
        <c:auto val="1"/>
        <c:lblAlgn val="ctr"/>
        <c:lblOffset val="100"/>
        <c:noMultiLvlLbl val="0"/>
      </c:catAx>
      <c:valAx>
        <c:axId val="90074112"/>
        <c:scaling>
          <c:orientation val="minMax"/>
          <c:max val="0.65"/>
          <c:min val="0.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OD</a:t>
                </a:r>
                <a:r>
                  <a:rPr lang="en-US" baseline="-25000" dirty="0" smtClean="0"/>
                  <a:t>600</a:t>
                </a:r>
                <a:endParaRPr lang="en-US" dirty="0"/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crossAx val="90072192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/>
            </a:pPr>
            <a:r>
              <a:rPr lang="en-US" sz="1100" b="0" i="1" baseline="0" dirty="0" smtClean="0">
                <a:effectLst/>
              </a:rPr>
              <a:t>Fusarium culmorum</a:t>
            </a:r>
            <a:endParaRPr lang="en-GB" sz="1100" dirty="0">
              <a:effectLst/>
            </a:endParaRP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v>Fc L-HS</c:v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65:$M$65</c:f>
                <c:numCache>
                  <c:formatCode>General</c:formatCode>
                  <c:ptCount val="12"/>
                  <c:pt idx="0">
                    <c:v>2.5296102370501401E-2</c:v>
                  </c:pt>
                  <c:pt idx="1">
                    <c:v>2.4624145383741299E-2</c:v>
                  </c:pt>
                  <c:pt idx="2">
                    <c:v>3.5717919674578297E-2</c:v>
                  </c:pt>
                  <c:pt idx="3">
                    <c:v>3.09779651190434E-2</c:v>
                  </c:pt>
                  <c:pt idx="4">
                    <c:v>1.3918687478031599E-2</c:v>
                  </c:pt>
                  <c:pt idx="5">
                    <c:v>5.0665501631342097E-3</c:v>
                  </c:pt>
                  <c:pt idx="6">
                    <c:v>1.0600621269354699E-2</c:v>
                  </c:pt>
                  <c:pt idx="7">
                    <c:v>1.1006606812206899E-2</c:v>
                  </c:pt>
                  <c:pt idx="8">
                    <c:v>8.1227856669211992E-3</c:v>
                  </c:pt>
                  <c:pt idx="9">
                    <c:v>1.24588675099156E-2</c:v>
                  </c:pt>
                  <c:pt idx="10">
                    <c:v>1.8353396061512501E-2</c:v>
                  </c:pt>
                  <c:pt idx="11">
                    <c:v>1.1104785004672499E-2</c:v>
                  </c:pt>
                </c:numCache>
              </c:numRef>
            </c:plus>
            <c:minus>
              <c:numRef>
                <c:f>Sheet1!$B$65:$M$65</c:f>
                <c:numCache>
                  <c:formatCode>General</c:formatCode>
                  <c:ptCount val="12"/>
                  <c:pt idx="0">
                    <c:v>2.5296102370501401E-2</c:v>
                  </c:pt>
                  <c:pt idx="1">
                    <c:v>2.4624145383741299E-2</c:v>
                  </c:pt>
                  <c:pt idx="2">
                    <c:v>3.5717919674578297E-2</c:v>
                  </c:pt>
                  <c:pt idx="3">
                    <c:v>3.09779651190434E-2</c:v>
                  </c:pt>
                  <c:pt idx="4">
                    <c:v>1.3918687478031599E-2</c:v>
                  </c:pt>
                  <c:pt idx="5">
                    <c:v>5.0665501631342097E-3</c:v>
                  </c:pt>
                  <c:pt idx="6">
                    <c:v>1.0600621269354699E-2</c:v>
                  </c:pt>
                  <c:pt idx="7">
                    <c:v>1.1006606812206899E-2</c:v>
                  </c:pt>
                  <c:pt idx="8">
                    <c:v>8.1227856669211992E-3</c:v>
                  </c:pt>
                  <c:pt idx="9">
                    <c:v>1.24588675099156E-2</c:v>
                  </c:pt>
                  <c:pt idx="10">
                    <c:v>1.8353396061512501E-2</c:v>
                  </c:pt>
                  <c:pt idx="11">
                    <c:v>1.1104785004672499E-2</c:v>
                  </c:pt>
                </c:numCache>
              </c:numRef>
            </c:minus>
          </c:errBars>
          <c:cat>
            <c:numRef>
              <c:f>Sheet1!$B$40:$M$40</c:f>
              <c:numCache>
                <c:formatCode>General</c:formatCode>
                <c:ptCount val="12"/>
                <c:pt idx="0">
                  <c:v>0</c:v>
                </c:pt>
                <c:pt idx="1">
                  <c:v>7.8125E-2</c:v>
                </c:pt>
                <c:pt idx="2">
                  <c:v>0.15625</c:v>
                </c:pt>
                <c:pt idx="3">
                  <c:v>0.3125</c:v>
                </c:pt>
                <c:pt idx="4">
                  <c:v>0.625</c:v>
                </c:pt>
                <c:pt idx="5">
                  <c:v>1.25</c:v>
                </c:pt>
                <c:pt idx="6">
                  <c:v>2.5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40</c:v>
                </c:pt>
                <c:pt idx="11">
                  <c:v>80</c:v>
                </c:pt>
              </c:numCache>
            </c:numRef>
          </c:cat>
          <c:val>
            <c:numRef>
              <c:f>Sheet1!$B$64:$M$64</c:f>
              <c:numCache>
                <c:formatCode>0.000</c:formatCode>
                <c:ptCount val="12"/>
                <c:pt idx="0">
                  <c:v>0.45590208333333299</c:v>
                </c:pt>
                <c:pt idx="1">
                  <c:v>0.48394375000000001</c:v>
                </c:pt>
                <c:pt idx="2">
                  <c:v>0.47991458333333298</c:v>
                </c:pt>
                <c:pt idx="3">
                  <c:v>0.46931458333333298</c:v>
                </c:pt>
                <c:pt idx="4">
                  <c:v>0.48454166666666698</c:v>
                </c:pt>
                <c:pt idx="5">
                  <c:v>0.46529583333333302</c:v>
                </c:pt>
                <c:pt idx="6">
                  <c:v>0.43417083333333301</c:v>
                </c:pt>
                <c:pt idx="7">
                  <c:v>0.44412083333333302</c:v>
                </c:pt>
                <c:pt idx="8">
                  <c:v>0.43824791666666701</c:v>
                </c:pt>
                <c:pt idx="9">
                  <c:v>0.44279166666666703</c:v>
                </c:pt>
                <c:pt idx="10">
                  <c:v>0.44267291666666703</c:v>
                </c:pt>
                <c:pt idx="11">
                  <c:v>0.423308333333333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103168"/>
        <c:axId val="90105344"/>
      </c:lineChart>
      <c:catAx>
        <c:axId val="901031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smtClean="0"/>
                  <a:t>L-homoserine </a:t>
                </a:r>
                <a:r>
                  <a:rPr lang="en-US" b="0" dirty="0" smtClean="0"/>
                  <a:t>concentration </a:t>
                </a:r>
                <a:r>
                  <a:rPr lang="en-US" b="0" dirty="0"/>
                  <a:t>(</a:t>
                </a:r>
                <a:r>
                  <a:rPr lang="en-US" b="0" dirty="0" err="1"/>
                  <a:t>mM</a:t>
                </a:r>
                <a:r>
                  <a:rPr lang="en-US" b="0" dirty="0"/>
                  <a:t>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0105344"/>
        <c:crosses val="autoZero"/>
        <c:auto val="1"/>
        <c:lblAlgn val="ctr"/>
        <c:lblOffset val="100"/>
        <c:noMultiLvlLbl val="0"/>
      </c:catAx>
      <c:valAx>
        <c:axId val="90105344"/>
        <c:scaling>
          <c:orientation val="minMax"/>
          <c:max val="0.65"/>
          <c:min val="0.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OD</a:t>
                </a:r>
                <a:r>
                  <a:rPr lang="en-US" baseline="-25000" dirty="0" smtClean="0"/>
                  <a:t>600</a:t>
                </a:r>
                <a:endParaRPr lang="en-US" dirty="0"/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crossAx val="90103168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 b="0"/>
            </a:pPr>
            <a:r>
              <a:rPr lang="en-US" sz="1100" b="0" i="1" dirty="0" smtClean="0"/>
              <a:t>Fusarium graminearum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66:$M$66</c:f>
              <c:strCache>
                <c:ptCount val="1"/>
                <c:pt idx="0">
                  <c:v>0.482 0.469 0.463 0.464 0.417 0.405 0.419 0.401 0.422 0.436 0.445 0.447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67:$M$67</c:f>
                <c:numCache>
                  <c:formatCode>General</c:formatCode>
                  <c:ptCount val="12"/>
                  <c:pt idx="0">
                    <c:v>1.14603894619847E-2</c:v>
                  </c:pt>
                  <c:pt idx="1">
                    <c:v>8.4047027179893208E-3</c:v>
                  </c:pt>
                  <c:pt idx="2">
                    <c:v>1.6083798208595401E-2</c:v>
                  </c:pt>
                  <c:pt idx="3">
                    <c:v>8.7190205553401498E-3</c:v>
                  </c:pt>
                  <c:pt idx="4">
                    <c:v>7.3224872444030498E-3</c:v>
                  </c:pt>
                  <c:pt idx="5">
                    <c:v>6.76961655733421E-3</c:v>
                  </c:pt>
                  <c:pt idx="6">
                    <c:v>1.21868515971867E-2</c:v>
                  </c:pt>
                  <c:pt idx="7">
                    <c:v>4.0594596885500803E-3</c:v>
                  </c:pt>
                  <c:pt idx="8">
                    <c:v>7.5557266116257496E-3</c:v>
                  </c:pt>
                  <c:pt idx="9">
                    <c:v>3.2244831627202299E-3</c:v>
                  </c:pt>
                  <c:pt idx="10">
                    <c:v>9.1719817292989208E-3</c:v>
                  </c:pt>
                  <c:pt idx="11">
                    <c:v>8.47695780674931E-3</c:v>
                  </c:pt>
                </c:numCache>
              </c:numRef>
            </c:plus>
            <c:minus>
              <c:numRef>
                <c:f>Sheet1!$B$67:$M$67</c:f>
                <c:numCache>
                  <c:formatCode>General</c:formatCode>
                  <c:ptCount val="12"/>
                  <c:pt idx="0">
                    <c:v>1.14603894619847E-2</c:v>
                  </c:pt>
                  <c:pt idx="1">
                    <c:v>8.4047027179893208E-3</c:v>
                  </c:pt>
                  <c:pt idx="2">
                    <c:v>1.6083798208595401E-2</c:v>
                  </c:pt>
                  <c:pt idx="3">
                    <c:v>8.7190205553401498E-3</c:v>
                  </c:pt>
                  <c:pt idx="4">
                    <c:v>7.3224872444030498E-3</c:v>
                  </c:pt>
                  <c:pt idx="5">
                    <c:v>6.76961655733421E-3</c:v>
                  </c:pt>
                  <c:pt idx="6">
                    <c:v>1.21868515971867E-2</c:v>
                  </c:pt>
                  <c:pt idx="7">
                    <c:v>4.0594596885500803E-3</c:v>
                  </c:pt>
                  <c:pt idx="8">
                    <c:v>7.5557266116257496E-3</c:v>
                  </c:pt>
                  <c:pt idx="9">
                    <c:v>3.2244831627202299E-3</c:v>
                  </c:pt>
                  <c:pt idx="10">
                    <c:v>9.1719817292989208E-3</c:v>
                  </c:pt>
                  <c:pt idx="11">
                    <c:v>8.47695780674931E-3</c:v>
                  </c:pt>
                </c:numCache>
              </c:numRef>
            </c:minus>
          </c:errBars>
          <c:cat>
            <c:numRef>
              <c:f>Sheet1!$B$40:$M$40</c:f>
              <c:numCache>
                <c:formatCode>General</c:formatCode>
                <c:ptCount val="12"/>
                <c:pt idx="0">
                  <c:v>0</c:v>
                </c:pt>
                <c:pt idx="1">
                  <c:v>7.8125E-2</c:v>
                </c:pt>
                <c:pt idx="2">
                  <c:v>0.15625</c:v>
                </c:pt>
                <c:pt idx="3">
                  <c:v>0.3125</c:v>
                </c:pt>
                <c:pt idx="4">
                  <c:v>0.625</c:v>
                </c:pt>
                <c:pt idx="5">
                  <c:v>1.25</c:v>
                </c:pt>
                <c:pt idx="6">
                  <c:v>2.5</c:v>
                </c:pt>
                <c:pt idx="7">
                  <c:v>5</c:v>
                </c:pt>
                <c:pt idx="8">
                  <c:v>10</c:v>
                </c:pt>
                <c:pt idx="9">
                  <c:v>20</c:v>
                </c:pt>
                <c:pt idx="10">
                  <c:v>40</c:v>
                </c:pt>
                <c:pt idx="11">
                  <c:v>80</c:v>
                </c:pt>
              </c:numCache>
            </c:numRef>
          </c:cat>
          <c:val>
            <c:numRef>
              <c:f>Sheet1!$B$66:$M$66</c:f>
              <c:numCache>
                <c:formatCode>0.000</c:formatCode>
                <c:ptCount val="12"/>
                <c:pt idx="0">
                  <c:v>0.48168125000000001</c:v>
                </c:pt>
                <c:pt idx="1">
                  <c:v>0.46920833333333301</c:v>
                </c:pt>
                <c:pt idx="2">
                  <c:v>0.46302500000000002</c:v>
                </c:pt>
                <c:pt idx="3">
                  <c:v>0.46422916666666703</c:v>
                </c:pt>
                <c:pt idx="4">
                  <c:v>0.41672916666666698</c:v>
                </c:pt>
                <c:pt idx="5">
                  <c:v>0.40541250000000001</c:v>
                </c:pt>
                <c:pt idx="6">
                  <c:v>0.418808333333333</c:v>
                </c:pt>
                <c:pt idx="7">
                  <c:v>0.401208333333333</c:v>
                </c:pt>
                <c:pt idx="8">
                  <c:v>0.42241250000000002</c:v>
                </c:pt>
                <c:pt idx="9">
                  <c:v>0.43632083333333299</c:v>
                </c:pt>
                <c:pt idx="10">
                  <c:v>0.445439583333333</c:v>
                </c:pt>
                <c:pt idx="11">
                  <c:v>0.447002083333333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126208"/>
        <c:axId val="90136576"/>
      </c:lineChart>
      <c:catAx>
        <c:axId val="901262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500"/>
                </a:pPr>
                <a:r>
                  <a:rPr lang="en-US" sz="1050" b="0" i="0" baseline="0" dirty="0" smtClean="0">
                    <a:effectLst/>
                  </a:rPr>
                  <a:t>L-homoserine </a:t>
                </a:r>
                <a:r>
                  <a:rPr lang="en-US" sz="1050" b="0" i="0" baseline="0" dirty="0" smtClean="0">
                    <a:effectLst/>
                  </a:rPr>
                  <a:t>concentration (</a:t>
                </a:r>
                <a:r>
                  <a:rPr lang="en-US" sz="1050" b="0" i="0" baseline="0" dirty="0" err="1" smtClean="0">
                    <a:effectLst/>
                  </a:rPr>
                  <a:t>mM</a:t>
                </a:r>
                <a:r>
                  <a:rPr lang="en-US" sz="1050" b="0" i="0" baseline="0" dirty="0" smtClean="0">
                    <a:effectLst/>
                  </a:rPr>
                  <a:t>)</a:t>
                </a:r>
                <a:endParaRPr lang="en-GB" sz="50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0136576"/>
        <c:crosses val="autoZero"/>
        <c:auto val="1"/>
        <c:lblAlgn val="ctr"/>
        <c:lblOffset val="100"/>
        <c:noMultiLvlLbl val="0"/>
      </c:catAx>
      <c:valAx>
        <c:axId val="90136576"/>
        <c:scaling>
          <c:orientation val="minMax"/>
          <c:max val="0.65"/>
          <c:min val="0.1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OD</a:t>
                </a:r>
                <a:r>
                  <a:rPr lang="en-US" baseline="-25000" dirty="0" smtClean="0"/>
                  <a:t>600</a:t>
                </a:r>
                <a:endParaRPr lang="en-US" dirty="0"/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crossAx val="90126208"/>
        <c:crosses val="autoZero"/>
        <c:crossBetween val="between"/>
        <c:majorUnit val="0.1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3C0B0D-0694-4100-96DA-6969BE4BF73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0D0795-5B49-472D-98CB-69F25B75C9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120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</a:t>
            </a:r>
            <a:r>
              <a:rPr lang="en-GB" sz="1200" i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GB" sz="1200" i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:</a:t>
            </a:r>
            <a:r>
              <a:rPr lang="en-GB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moserine does not inhibit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sarium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yphal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rowth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vitro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Spores of either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. culmorum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. graminearum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re cultured for 2 days in synthetic nutrient poor media supplemented with (a, b) D-homoserine and (c, d) L-homoserine at concentrations ranging from 0 to 80mM. Graphs show the optical density at 600nm of fungal colonies after 2 days growth. The experiment was repeated with similar findings.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0D0795-5B49-472D-98CB-69F25B75C9A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98745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9339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942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7011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575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2745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805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072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3509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9607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932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1691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394D9-294F-41C6-A820-7F00B4088755}" type="datetimeFigureOut">
              <a:rPr lang="en-GB" smtClean="0"/>
              <a:t>28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96B56-00CE-4E10-BFDF-7A35D3E56C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900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2093414"/>
              </p:ext>
            </p:extLst>
          </p:nvPr>
        </p:nvGraphicFramePr>
        <p:xfrm>
          <a:off x="251520" y="476672"/>
          <a:ext cx="3970784" cy="2520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0792064"/>
              </p:ext>
            </p:extLst>
          </p:nvPr>
        </p:nvGraphicFramePr>
        <p:xfrm>
          <a:off x="4738307" y="476672"/>
          <a:ext cx="4034905" cy="2520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1015605"/>
              </p:ext>
            </p:extLst>
          </p:nvPr>
        </p:nvGraphicFramePr>
        <p:xfrm>
          <a:off x="274115" y="3078871"/>
          <a:ext cx="4042792" cy="2521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920888"/>
              </p:ext>
            </p:extLst>
          </p:nvPr>
        </p:nvGraphicFramePr>
        <p:xfrm>
          <a:off x="4772835" y="3078871"/>
          <a:ext cx="3938515" cy="2532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0" y="0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4572000" y="938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0" y="2813194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572000" y="2780928"/>
            <a:ext cx="2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2" name="Rectangle 1"/>
          <p:cNvSpPr/>
          <p:nvPr/>
        </p:nvSpPr>
        <p:spPr>
          <a:xfrm>
            <a:off x="0" y="6021288"/>
            <a:ext cx="9144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i="1" dirty="0"/>
              <a:t>Supplementary Figure </a:t>
            </a:r>
            <a:r>
              <a:rPr lang="en-GB" sz="1200" i="1" dirty="0" smtClean="0"/>
              <a:t>2:</a:t>
            </a:r>
            <a:r>
              <a:rPr lang="en-GB" sz="1200" dirty="0" smtClean="0"/>
              <a:t> </a:t>
            </a:r>
            <a:r>
              <a:rPr lang="en-GB" sz="1200" dirty="0"/>
              <a:t>Homoserine does not inhibit </a:t>
            </a:r>
            <a:r>
              <a:rPr lang="en-GB" sz="1200" i="1" dirty="0"/>
              <a:t>Fusarium</a:t>
            </a:r>
            <a:r>
              <a:rPr lang="en-GB" sz="1200" dirty="0"/>
              <a:t> </a:t>
            </a:r>
            <a:r>
              <a:rPr lang="en-GB" sz="1200" dirty="0" err="1"/>
              <a:t>hyphal</a:t>
            </a:r>
            <a:r>
              <a:rPr lang="en-GB" sz="1200" dirty="0"/>
              <a:t> growth </a:t>
            </a:r>
            <a:r>
              <a:rPr lang="en-GB" sz="1200" i="1" dirty="0"/>
              <a:t>in vitro</a:t>
            </a:r>
            <a:r>
              <a:rPr lang="en-GB" sz="1200" dirty="0"/>
              <a:t>. Spores of either </a:t>
            </a:r>
            <a:r>
              <a:rPr lang="en-GB" sz="1200" i="1" dirty="0"/>
              <a:t>F. culmorum</a:t>
            </a:r>
            <a:r>
              <a:rPr lang="en-GB" sz="1200" dirty="0"/>
              <a:t> or </a:t>
            </a:r>
            <a:r>
              <a:rPr lang="en-GB" sz="1200" i="1" dirty="0"/>
              <a:t>F. graminearum </a:t>
            </a:r>
            <a:r>
              <a:rPr lang="en-GB" sz="1200" dirty="0"/>
              <a:t>were cultured for 2 days in synthetic nutrient poor media supplemented with (a, b) D-homoserine and (c, d) L-homoserine at concentrations ranging from 0 to 80mM. Graphs show the optical density at 600nm of fungal colonies after 2 days growth. The experiment was repeated with similar findings.</a:t>
            </a:r>
          </a:p>
        </p:txBody>
      </p:sp>
    </p:spTree>
    <p:extLst>
      <p:ext uri="{BB962C8B-B14F-4D97-AF65-F5344CB8AC3E}">
        <p14:creationId xmlns:p14="http://schemas.microsoft.com/office/powerpoint/2010/main" val="2164037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197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Brewer (RRes-Roth)</dc:creator>
  <cp:lastModifiedBy>Helen Brewer (RRes-Roth)</cp:lastModifiedBy>
  <cp:revision>9</cp:revision>
  <dcterms:created xsi:type="dcterms:W3CDTF">2013-10-08T15:08:53Z</dcterms:created>
  <dcterms:modified xsi:type="dcterms:W3CDTF">2014-03-28T21:41:48Z</dcterms:modified>
</cp:coreProperties>
</file>